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6" r:id="rId2"/>
    <p:sldId id="293" r:id="rId3"/>
    <p:sldId id="294" r:id="rId4"/>
    <p:sldId id="263" r:id="rId5"/>
    <p:sldId id="295" r:id="rId6"/>
    <p:sldId id="291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7" r:id="rId19"/>
    <p:sldId id="299" r:id="rId20"/>
    <p:sldId id="279" r:id="rId21"/>
    <p:sldId id="298" r:id="rId22"/>
    <p:sldId id="297" r:id="rId23"/>
    <p:sldId id="281" r:id="rId24"/>
    <p:sldId id="283" r:id="rId25"/>
    <p:sldId id="282" r:id="rId2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34" userDrawn="1">
          <p15:clr>
            <a:srgbClr val="A4A3A4"/>
          </p15:clr>
        </p15:guide>
        <p15:guide id="2" pos="36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942" y="78"/>
      </p:cViewPr>
      <p:guideLst>
        <p:guide orient="horz" pos="1434"/>
        <p:guide pos="36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43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2469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235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88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6738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6023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2783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3654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162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5768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8233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7FC42-0F6B-4B37-B0B4-ECF7E507C07E}" type="datetimeFigureOut">
              <a:rPr lang="ko-KR" altLang="en-US" smtClean="0"/>
              <a:pPr/>
              <a:t>2020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3DC430-A55A-45BE-9C64-119DDB6487C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6069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7" Type="http://schemas.openxmlformats.org/officeDocument/2006/relationships/image" Target="../media/image26.png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tif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57991" y="6207788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(A). Gel electrophoresis images of Northern blot of organs and fruits</a:t>
            </a:r>
            <a:endParaRPr lang="ko-KR" alt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1913" y="137561"/>
            <a:ext cx="5635792" cy="60377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7557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802" y="402457"/>
            <a:ext cx="7967713" cy="506669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20840" y="5871360"/>
            <a:ext cx="8547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9. </a:t>
            </a:r>
            <a:r>
              <a:rPr lang="en-US" altLang="ko-KR" dirty="0"/>
              <a:t>Gel electrophoresis images 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ACS4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5389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5188" y="323248"/>
            <a:ext cx="8201928" cy="530022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946482" y="5847297"/>
            <a:ext cx="63446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9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E4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73028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1788" y="300188"/>
            <a:ext cx="8125327" cy="5447286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946482" y="5847297"/>
            <a:ext cx="63446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9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E8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92045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913" y="236020"/>
            <a:ext cx="8298982" cy="6275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759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514" y="391227"/>
            <a:ext cx="8490886" cy="418157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962527" y="5370646"/>
            <a:ext cx="65933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1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N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649241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950495" y="5142046"/>
            <a:ext cx="65933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1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HB1</a:t>
            </a:r>
            <a:endParaRPr lang="ko-KR" alt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012" y="312621"/>
            <a:ext cx="8574103" cy="4452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146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950495" y="5142046"/>
            <a:ext cx="65933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1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CNR</a:t>
            </a:r>
            <a:endParaRPr lang="ko-KR" altLang="en-US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205" y="328663"/>
            <a:ext cx="8553902" cy="4147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5340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133158" y="5559351"/>
            <a:ext cx="65933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1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TAGL1</a:t>
            </a:r>
            <a:endParaRPr lang="ko-KR" altLang="en-US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821" y="498708"/>
            <a:ext cx="8708673" cy="44330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258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263" y="1177701"/>
            <a:ext cx="8076233" cy="287694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48917" y="4897614"/>
            <a:ext cx="8506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. Gel </a:t>
            </a:r>
            <a:r>
              <a:rPr lang="en-US" altLang="ko-KR" dirty="0"/>
              <a:t>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18S RNA used in Figure 7, 9 and 1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28406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8131" y="390012"/>
            <a:ext cx="2126007" cy="1605331"/>
          </a:xfrm>
          <a:prstGeom prst="rect">
            <a:avLst/>
          </a:prstGeom>
        </p:spPr>
      </p:pic>
      <p:sp>
        <p:nvSpPr>
          <p:cNvPr id="19" name="TextBox 16"/>
          <p:cNvSpPr txBox="1">
            <a:spLocks noChangeArrowheads="1"/>
          </p:cNvSpPr>
          <p:nvPr/>
        </p:nvSpPr>
        <p:spPr bwMode="auto">
          <a:xfrm>
            <a:off x="2045399" y="63637"/>
            <a:ext cx="111702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4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B3 stage</a:t>
            </a:r>
            <a:endParaRPr lang="ko-KR" altLang="en-US" sz="1400" b="1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6" name="그룹 25"/>
          <p:cNvGrpSpPr/>
          <p:nvPr/>
        </p:nvGrpSpPr>
        <p:grpSpPr>
          <a:xfrm>
            <a:off x="1950842" y="390143"/>
            <a:ext cx="1306138" cy="420783"/>
            <a:chOff x="6084136" y="2126263"/>
            <a:chExt cx="1306138" cy="446275"/>
          </a:xfrm>
        </p:grpSpPr>
        <p:sp>
          <p:nvSpPr>
            <p:cNvPr id="16" name="TextBox 12"/>
            <p:cNvSpPr txBox="1">
              <a:spLocks noChangeArrowheads="1"/>
            </p:cNvSpPr>
            <p:nvPr/>
          </p:nvSpPr>
          <p:spPr bwMode="auto">
            <a:xfrm>
              <a:off x="6084136" y="2126263"/>
              <a:ext cx="130613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ko-KR" sz="900" dirty="0" smtClean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WT  </a:t>
              </a:r>
              <a:r>
                <a:rPr lang="en-US" altLang="ko-KR" sz="900" i="1" dirty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miR172</a:t>
              </a:r>
              <a:r>
                <a:rPr lang="en-US" altLang="ko-KR" sz="900" dirty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900" dirty="0" smtClean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OE</a:t>
              </a:r>
              <a:endParaRPr lang="ko-KR" altLang="en-US" sz="900" dirty="0">
                <a:solidFill>
                  <a:srgbClr val="FFFF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18" name="직선 연결선 15"/>
            <p:cNvCxnSpPr>
              <a:cxnSpLocks noChangeShapeType="1"/>
            </p:cNvCxnSpPr>
            <p:nvPr/>
          </p:nvCxnSpPr>
          <p:spPr bwMode="auto">
            <a:xfrm>
              <a:off x="6084136" y="2348066"/>
              <a:ext cx="1131311" cy="9029"/>
            </a:xfrm>
            <a:prstGeom prst="line">
              <a:avLst/>
            </a:prstGeom>
            <a:noFill/>
            <a:ln w="9525" algn="ctr">
              <a:solidFill>
                <a:srgbClr val="FFFF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0" name="TextBox 17"/>
            <p:cNvSpPr txBox="1">
              <a:spLocks noChangeArrowheads="1"/>
            </p:cNvSpPr>
            <p:nvPr/>
          </p:nvSpPr>
          <p:spPr bwMode="auto">
            <a:xfrm>
              <a:off x="6412620" y="2341706"/>
              <a:ext cx="7858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900" dirty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#</a:t>
              </a:r>
              <a:r>
                <a:rPr lang="en-US" altLang="ko-KR" sz="900" dirty="0" smtClean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13  #16</a:t>
              </a:r>
              <a:endParaRPr lang="ko-KR" altLang="en-US" sz="900" dirty="0">
                <a:solidFill>
                  <a:srgbClr val="FFFF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5" name="직선 연결선 15"/>
            <p:cNvCxnSpPr>
              <a:cxnSpLocks noChangeShapeType="1"/>
            </p:cNvCxnSpPr>
            <p:nvPr/>
          </p:nvCxnSpPr>
          <p:spPr bwMode="auto">
            <a:xfrm>
              <a:off x="6084136" y="2132623"/>
              <a:ext cx="1131311" cy="9029"/>
            </a:xfrm>
            <a:prstGeom prst="line">
              <a:avLst/>
            </a:prstGeom>
            <a:noFill/>
            <a:ln w="9525" algn="ctr">
              <a:solidFill>
                <a:srgbClr val="FFFF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27" name="TextBox 35"/>
          <p:cNvSpPr txBox="1">
            <a:spLocks noChangeArrowheads="1"/>
          </p:cNvSpPr>
          <p:nvPr/>
        </p:nvSpPr>
        <p:spPr bwMode="auto">
          <a:xfrm>
            <a:off x="731838" y="893464"/>
            <a:ext cx="838286" cy="279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lAP2a</a:t>
            </a:r>
            <a:endParaRPr lang="ko-KR" altLang="en-US" sz="1200" i="1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28" name="TextBox 36"/>
          <p:cNvSpPr txBox="1">
            <a:spLocks noChangeArrowheads="1"/>
          </p:cNvSpPr>
          <p:nvPr/>
        </p:nvSpPr>
        <p:spPr bwMode="auto">
          <a:xfrm>
            <a:off x="440543" y="2659182"/>
            <a:ext cx="960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lAP2c</a:t>
            </a:r>
            <a:endParaRPr lang="ko-KR" altLang="en-US" sz="1200" i="1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0" name="그림 2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3471" y="2044794"/>
            <a:ext cx="2003655" cy="1564871"/>
          </a:xfrm>
          <a:prstGeom prst="rect">
            <a:avLst/>
          </a:prstGeom>
        </p:spPr>
      </p:pic>
      <p:sp>
        <p:nvSpPr>
          <p:cNvPr id="31" name="TextBox 37"/>
          <p:cNvSpPr txBox="1">
            <a:spLocks noChangeArrowheads="1"/>
          </p:cNvSpPr>
          <p:nvPr/>
        </p:nvSpPr>
        <p:spPr bwMode="auto">
          <a:xfrm>
            <a:off x="440544" y="4204767"/>
            <a:ext cx="882807" cy="276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arget 4</a:t>
            </a:r>
            <a:endParaRPr lang="ko-KR" altLang="en-US" sz="1200" i="1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9" name="그림 3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3471" y="3625273"/>
            <a:ext cx="1915280" cy="1246465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4357850" y="107867"/>
            <a:ext cx="3461346" cy="1509570"/>
            <a:chOff x="-284402" y="5291290"/>
            <a:chExt cx="3461346" cy="1509570"/>
          </a:xfrm>
        </p:grpSpPr>
        <p:pic>
          <p:nvPicPr>
            <p:cNvPr id="43" name="그림 4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743" y="5291290"/>
              <a:ext cx="2548201" cy="1509570"/>
            </a:xfrm>
            <a:prstGeom prst="rect">
              <a:avLst/>
            </a:prstGeom>
          </p:spPr>
        </p:pic>
        <p:sp>
          <p:nvSpPr>
            <p:cNvPr id="44" name="TextBox 39"/>
            <p:cNvSpPr txBox="1">
              <a:spLocks noChangeArrowheads="1"/>
            </p:cNvSpPr>
            <p:nvPr/>
          </p:nvSpPr>
          <p:spPr bwMode="auto">
            <a:xfrm>
              <a:off x="-284402" y="5914435"/>
              <a:ext cx="820137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i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lEF1-</a:t>
              </a:r>
              <a:r>
                <a:rPr lang="el-GR" altLang="ko-KR" sz="1200" i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α</a:t>
              </a:r>
              <a:endParaRPr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   (control)</a:t>
              </a:r>
              <a:endParaRPr lang="ko-KR" altLang="en-US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556482" y="1746059"/>
            <a:ext cx="4448891" cy="2847003"/>
            <a:chOff x="4463165" y="346636"/>
            <a:chExt cx="4448891" cy="2847003"/>
          </a:xfrm>
        </p:grpSpPr>
        <p:sp>
          <p:nvSpPr>
            <p:cNvPr id="53" name="TextBox 40"/>
            <p:cNvSpPr txBox="1">
              <a:spLocks noChangeArrowheads="1"/>
            </p:cNvSpPr>
            <p:nvPr/>
          </p:nvSpPr>
          <p:spPr bwMode="auto">
            <a:xfrm>
              <a:off x="4463165" y="2371131"/>
              <a:ext cx="82013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i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lAP2b</a:t>
              </a:r>
              <a:endParaRPr lang="ko-KR" altLang="en-US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5177678" y="346636"/>
              <a:ext cx="3734378" cy="2847003"/>
              <a:chOff x="5177678" y="346636"/>
              <a:chExt cx="3734378" cy="2847003"/>
            </a:xfrm>
          </p:grpSpPr>
          <p:pic>
            <p:nvPicPr>
              <p:cNvPr id="62" name="그림 61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63"/>
              <a:stretch/>
            </p:blipFill>
            <p:spPr>
              <a:xfrm>
                <a:off x="5177678" y="690237"/>
                <a:ext cx="2818380" cy="2503402"/>
              </a:xfrm>
              <a:prstGeom prst="rect">
                <a:avLst/>
              </a:prstGeom>
            </p:spPr>
          </p:pic>
          <p:sp>
            <p:nvSpPr>
              <p:cNvPr id="50" name="TextBox 25"/>
              <p:cNvSpPr txBox="1">
                <a:spLocks noChangeArrowheads="1"/>
              </p:cNvSpPr>
              <p:nvPr/>
            </p:nvSpPr>
            <p:spPr bwMode="auto">
              <a:xfrm>
                <a:off x="5460342" y="840110"/>
                <a:ext cx="108757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000" dirty="0" smtClean="0">
                    <a:solidFill>
                      <a:srgbClr val="FFFF00"/>
                    </a:solidFill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WT  </a:t>
                </a:r>
                <a:r>
                  <a:rPr lang="en-US" altLang="ko-KR" sz="1000" i="1" spc="-150" dirty="0" smtClean="0">
                    <a:solidFill>
                      <a:srgbClr val="FFFF00"/>
                    </a:solidFill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miR172</a:t>
                </a:r>
                <a:r>
                  <a:rPr lang="en-US" altLang="ko-KR" sz="1000" spc="-150" dirty="0" smtClean="0">
                    <a:solidFill>
                      <a:srgbClr val="FFFF00"/>
                    </a:solidFill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000" spc="-15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OE  #13</a:t>
                </a:r>
                <a:endParaRPr lang="ko-KR" altLang="en-US" sz="1000" spc="-150" dirty="0">
                  <a:solidFill>
                    <a:srgbClr val="FFFF00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27"/>
              <p:cNvSpPr txBox="1">
                <a:spLocks noChangeArrowheads="1"/>
              </p:cNvSpPr>
              <p:nvPr/>
            </p:nvSpPr>
            <p:spPr bwMode="auto">
              <a:xfrm>
                <a:off x="6320634" y="346636"/>
                <a:ext cx="95371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400" b="1" dirty="0"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Flower</a:t>
                </a:r>
                <a:endParaRPr lang="ko-KR" altLang="en-US" sz="14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0" name="직선 연결선 26"/>
              <p:cNvCxnSpPr>
                <a:cxnSpLocks noChangeShapeType="1"/>
              </p:cNvCxnSpPr>
              <p:nvPr/>
            </p:nvCxnSpPr>
            <p:spPr bwMode="auto">
              <a:xfrm>
                <a:off x="5618867" y="1120738"/>
                <a:ext cx="814682" cy="4409"/>
              </a:xfrm>
              <a:prstGeom prst="line">
                <a:avLst/>
              </a:prstGeom>
              <a:noFill/>
              <a:ln w="9525" algn="ctr">
                <a:solidFill>
                  <a:srgbClr val="FFFF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68" name="직선 연결선 26"/>
              <p:cNvCxnSpPr>
                <a:cxnSpLocks noChangeShapeType="1"/>
              </p:cNvCxnSpPr>
              <p:nvPr/>
            </p:nvCxnSpPr>
            <p:spPr bwMode="auto">
              <a:xfrm>
                <a:off x="5597068" y="825438"/>
                <a:ext cx="836481" cy="14672"/>
              </a:xfrm>
              <a:prstGeom prst="line">
                <a:avLst/>
              </a:prstGeom>
              <a:noFill/>
              <a:ln w="9525" algn="ctr">
                <a:solidFill>
                  <a:srgbClr val="FFFF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70" name="TextBox 39"/>
              <p:cNvSpPr txBox="1">
                <a:spLocks noChangeArrowheads="1"/>
              </p:cNvSpPr>
              <p:nvPr/>
            </p:nvSpPr>
            <p:spPr bwMode="auto">
              <a:xfrm>
                <a:off x="7907683" y="2047965"/>
                <a:ext cx="1004373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200" i="1" dirty="0"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SlEF1-</a:t>
                </a:r>
                <a:r>
                  <a:rPr lang="el-GR" altLang="ko-KR" sz="1200" i="1" dirty="0"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α</a:t>
                </a:r>
                <a:endParaRPr lang="en-US" altLang="ko-KR" sz="1200" i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endParaRP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200" dirty="0">
                    <a:latin typeface="Times New Roman" panose="02020603050405020304" pitchFamily="18" charset="0"/>
                    <a:ea typeface="굴림" panose="020B0600000101010101" pitchFamily="50" charset="-127"/>
                    <a:cs typeface="Times New Roman" panose="02020603050405020304" pitchFamily="18" charset="0"/>
                  </a:rPr>
                  <a:t>   (control)</a:t>
                </a:r>
                <a:endParaRPr lang="ko-KR" altLang="en-US" sz="1200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75" name="TextBox 41"/>
          <p:cNvSpPr txBox="1">
            <a:spLocks noChangeArrowheads="1"/>
          </p:cNvSpPr>
          <p:nvPr/>
        </p:nvSpPr>
        <p:spPr bwMode="auto">
          <a:xfrm>
            <a:off x="3910263" y="5291745"/>
            <a:ext cx="5140420" cy="13388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>
              <a:lnSpc>
                <a:spcPct val="150000"/>
              </a:lnSpc>
              <a:spcBef>
                <a:spcPct val="0"/>
              </a:spcBef>
              <a:buNone/>
            </a:pPr>
            <a:r>
              <a:rPr lang="en-US" altLang="ko-KR" sz="18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upplementary Fig 1. </a:t>
            </a:r>
            <a:r>
              <a:rPr lang="en-US" altLang="ko-KR" sz="1800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RACE-PCR </a:t>
            </a:r>
            <a:r>
              <a:rPr lang="en-US" altLang="ko-K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</a:t>
            </a:r>
            <a:r>
              <a:rPr lang="en-US" altLang="ko-KR" sz="1800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8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of cleaved products of miR172 targets in wild type and </a:t>
            </a:r>
            <a:r>
              <a:rPr lang="en-US" altLang="ko-KR" sz="18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iR172</a:t>
            </a:r>
            <a:r>
              <a:rPr lang="en-US" altLang="ko-KR" sz="18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OE </a:t>
            </a:r>
            <a:r>
              <a:rPr lang="en-US" altLang="ko-KR" sz="1800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lines</a:t>
            </a:r>
            <a:endParaRPr lang="en-US" altLang="ko-KR" sz="18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549309" y="4887346"/>
            <a:ext cx="2839441" cy="1972102"/>
            <a:chOff x="536226" y="4843907"/>
            <a:chExt cx="2455564" cy="1972102"/>
          </a:xfrm>
        </p:grpSpPr>
        <p:sp>
          <p:nvSpPr>
            <p:cNvPr id="74" name="TextBox 37"/>
            <p:cNvSpPr txBox="1">
              <a:spLocks noChangeArrowheads="1"/>
            </p:cNvSpPr>
            <p:nvPr/>
          </p:nvSpPr>
          <p:spPr bwMode="auto">
            <a:xfrm>
              <a:off x="536226" y="5917720"/>
              <a:ext cx="66989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i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Target </a:t>
              </a:r>
              <a:r>
                <a:rPr lang="en-US" altLang="ko-KR" sz="1200" i="1" dirty="0" smtClean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5</a:t>
              </a:r>
              <a:endParaRPr lang="ko-KR" altLang="en-US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322180" y="4843907"/>
              <a:ext cx="1669610" cy="19721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55093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18669" y="5350915"/>
            <a:ext cx="80852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1(B</a:t>
            </a:r>
            <a:r>
              <a:rPr lang="en-US" altLang="ko-KR" dirty="0"/>
              <a:t>). Gel electrophoresis images of Northern blot </a:t>
            </a:r>
            <a:r>
              <a:rPr lang="en-US" altLang="ko-KR" dirty="0" smtClean="0"/>
              <a:t>of miR172 in different flower parts</a:t>
            </a:r>
            <a:endParaRPr lang="ko-KR" alt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579" y="934746"/>
            <a:ext cx="4236300" cy="353025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2837" y="1677258"/>
            <a:ext cx="4230693" cy="253484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5162099" y="3139235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0"/>
              </a:spcBef>
            </a:pP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5SRNA</a:t>
            </a:r>
            <a:endParaRPr lang="ko-KR" altLang="en-US" sz="12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8504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1352989" y="5537822"/>
            <a:ext cx="72616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 of o</a:t>
            </a:r>
            <a:r>
              <a:rPr lang="en-US" altLang="ko-KR" dirty="0" smtClean="0"/>
              <a:t>riginal Northern blot of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AP2a</a:t>
            </a:r>
            <a:endParaRPr lang="ko-KR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044" y="515754"/>
            <a:ext cx="8575431" cy="4693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668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772" y="507732"/>
            <a:ext cx="8605300" cy="4629752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016105" y="5394901"/>
            <a:ext cx="7261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 of o</a:t>
            </a:r>
            <a:r>
              <a:rPr lang="en-US" altLang="ko-KR" dirty="0" smtClean="0"/>
              <a:t>riginal </a:t>
            </a:r>
            <a:r>
              <a:rPr lang="en-US" altLang="ko-KR" dirty="0" err="1" smtClean="0"/>
              <a:t>Notherrn</a:t>
            </a:r>
            <a:r>
              <a:rPr lang="en-US" altLang="ko-KR" dirty="0" smtClean="0"/>
              <a:t> blot of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126051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010654" y="6211669"/>
            <a:ext cx="6870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 of o</a:t>
            </a:r>
            <a:r>
              <a:rPr lang="en-US" altLang="ko-KR" dirty="0"/>
              <a:t>riginal </a:t>
            </a:r>
            <a:r>
              <a:rPr lang="en-US" altLang="ko-KR" dirty="0" smtClean="0"/>
              <a:t>Northern </a:t>
            </a:r>
            <a:r>
              <a:rPr lang="en-US" altLang="ko-KR" dirty="0"/>
              <a:t>blot of </a:t>
            </a:r>
            <a:r>
              <a:rPr lang="en-US" altLang="ko-KR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n</a:t>
            </a:r>
            <a:endParaRPr lang="ko-KR" altLang="en-US" i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507" y="324852"/>
            <a:ext cx="6380356" cy="5742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4675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858625" y="6137854"/>
            <a:ext cx="8405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l image of o</a:t>
            </a:r>
            <a:r>
              <a:rPr lang="en-US" altLang="ko-KR" dirty="0"/>
              <a:t>riginal Northern blot of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</a:t>
            </a:r>
            <a:endParaRPr lang="ko-KR" altLang="en-US" i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8047" y="136759"/>
            <a:ext cx="5215890" cy="5862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0965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49211" y="6217375"/>
            <a:ext cx="7347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image of o</a:t>
            </a:r>
            <a:r>
              <a:rPr lang="en-US" altLang="ko-KR" dirty="0"/>
              <a:t>riginal Northern blot of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endParaRPr lang="ko-KR" altLang="en-US" i="1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6761" y="254868"/>
            <a:ext cx="4819049" cy="5548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0686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303791" y="6414582"/>
            <a:ext cx="7840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l image of o</a:t>
            </a:r>
            <a:r>
              <a:rPr lang="en-US" altLang="ko-KR" dirty="0"/>
              <a:t>riginal Northern blot of </a:t>
            </a:r>
            <a:r>
              <a:rPr lang="en-US" altLang="ko-KR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nr</a:t>
            </a:r>
            <a:endParaRPr lang="ko-KR" altLang="en-US" i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5732" y="379194"/>
            <a:ext cx="7064341" cy="5979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6091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6253" y="5823609"/>
            <a:ext cx="9047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2</a:t>
            </a:r>
            <a:r>
              <a:rPr lang="en-US" altLang="ko-KR" dirty="0"/>
              <a:t>.</a:t>
            </a:r>
            <a:r>
              <a:rPr lang="en-US" altLang="ko-KR" dirty="0">
                <a:solidFill>
                  <a:srgbClr val="FF0000"/>
                </a:solidFill>
              </a:rPr>
              <a:t> </a:t>
            </a:r>
            <a:r>
              <a:rPr lang="en-US" altLang="ko-KR" dirty="0"/>
              <a:t>Gel electrophoresis images of Northern blot </a:t>
            </a:r>
            <a:r>
              <a:rPr lang="en-US" altLang="ko-KR" dirty="0" smtClean="0"/>
              <a:t>of miR172 in flower and B3 stage of fruit</a:t>
            </a:r>
            <a:endParaRPr lang="ko-KR" alt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253" y="819079"/>
            <a:ext cx="4482403" cy="37157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7905" y="1471252"/>
            <a:ext cx="4536095" cy="3063594"/>
          </a:xfrm>
          <a:prstGeom prst="rect">
            <a:avLst/>
          </a:prstGeom>
        </p:spPr>
      </p:pic>
      <p:sp>
        <p:nvSpPr>
          <p:cNvPr id="11" name="직사각형 10"/>
          <p:cNvSpPr/>
          <p:nvPr/>
        </p:nvSpPr>
        <p:spPr>
          <a:xfrm>
            <a:off x="5024753" y="2944681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0"/>
              </a:spcBef>
            </a:pP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5SRNA</a:t>
            </a:r>
            <a:endParaRPr lang="ko-KR" altLang="en-US" sz="12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409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697078" y="4780164"/>
            <a:ext cx="8227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7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blot </a:t>
            </a:r>
            <a:r>
              <a:rPr lang="en-US" altLang="ko-KR" dirty="0" smtClean="0"/>
              <a:t>of </a:t>
            </a:r>
            <a:r>
              <a:rPr lang="en-US" altLang="ko-KR" i="1" dirty="0" smtClean="0"/>
              <a:t>DXS</a:t>
            </a:r>
            <a:endParaRPr lang="ko-KR" alt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521" y="488462"/>
            <a:ext cx="8835013" cy="3142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7766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908" y="876099"/>
            <a:ext cx="8644410" cy="315448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97078" y="4780164"/>
            <a:ext cx="8227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7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PSY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482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40632" y="6476623"/>
            <a:ext cx="890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7. </a:t>
            </a:r>
            <a:r>
              <a:rPr lang="en-US" altLang="ko-KR" dirty="0"/>
              <a:t>Gel electrophoresis images of Northern </a:t>
            </a:r>
            <a:r>
              <a:rPr lang="en-US" altLang="ko-KR" dirty="0" smtClean="0"/>
              <a:t>blot of </a:t>
            </a:r>
            <a:r>
              <a:rPr lang="en-US" altLang="ko-KR" i="1" dirty="0"/>
              <a:t>ZDS</a:t>
            </a:r>
            <a:r>
              <a:rPr lang="en-US" altLang="ko-KR" dirty="0"/>
              <a:t> </a:t>
            </a:r>
            <a:r>
              <a:rPr lang="en-US" altLang="ko-KR" dirty="0" smtClean="0"/>
              <a:t>and </a:t>
            </a:r>
            <a:r>
              <a:rPr lang="en-US" altLang="ko-KR" i="1" dirty="0" smtClean="0"/>
              <a:t>PDS</a:t>
            </a:r>
            <a:endParaRPr lang="ko-KR" alt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733" y="0"/>
            <a:ext cx="7566660" cy="6431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067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240632" y="5999181"/>
            <a:ext cx="890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7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CYC-B</a:t>
            </a:r>
            <a:endParaRPr lang="ko-KR" alt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112" y="153402"/>
            <a:ext cx="8291162" cy="54961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3656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765" y="252261"/>
            <a:ext cx="8631856" cy="5326039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367765" y="6039799"/>
            <a:ext cx="8523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9. </a:t>
            </a:r>
            <a:r>
              <a:rPr lang="en-US" altLang="ko-KR" dirty="0"/>
              <a:t>Gel electrophoresis </a:t>
            </a:r>
            <a:r>
              <a:rPr lang="en-US" altLang="ko-KR" dirty="0" smtClean="0"/>
              <a:t>image </a:t>
            </a:r>
            <a:r>
              <a:rPr lang="en-US" altLang="ko-KR" dirty="0"/>
              <a:t>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ACO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39497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567" y="193508"/>
            <a:ext cx="7732696" cy="5890448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67765" y="6111991"/>
            <a:ext cx="8547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9. </a:t>
            </a:r>
            <a:r>
              <a:rPr lang="en-US" altLang="ko-KR" dirty="0"/>
              <a:t>Gel electrophoresis images of Northern </a:t>
            </a:r>
            <a:r>
              <a:rPr lang="en-US" altLang="ko-KR" dirty="0" smtClean="0"/>
              <a:t>blot of </a:t>
            </a:r>
            <a:r>
              <a:rPr lang="en-US" altLang="ko-KR" i="1" dirty="0" smtClean="0"/>
              <a:t>ACS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79821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9</TotalTime>
  <Words>337</Words>
  <Application>Microsoft Office PowerPoint</Application>
  <PresentationFormat>On-screen Show (4:3)</PresentationFormat>
  <Paragraphs>40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2" baseType="lpstr">
      <vt:lpstr>맑은 고딕</vt:lpstr>
      <vt:lpstr>Arial</vt:lpstr>
      <vt:lpstr>Calibri</vt:lpstr>
      <vt:lpstr>Calibri Light</vt:lpstr>
      <vt:lpstr>굴림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UKN</cp:lastModifiedBy>
  <cp:revision>76</cp:revision>
  <dcterms:created xsi:type="dcterms:W3CDTF">2020-05-25T09:02:55Z</dcterms:created>
  <dcterms:modified xsi:type="dcterms:W3CDTF">2020-06-06T15:42:57Z</dcterms:modified>
</cp:coreProperties>
</file>